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82" r:id="rId2"/>
    <p:sldId id="284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842" userDrawn="1">
          <p15:clr>
            <a:srgbClr val="A4A3A4"/>
          </p15:clr>
        </p15:guide>
        <p15:guide id="3" orient="horz" pos="177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81"/>
  </p:normalViewPr>
  <p:slideViewPr>
    <p:cSldViewPr snapToGrid="0" showGuides="1">
      <p:cViewPr varScale="1">
        <p:scale>
          <a:sx n="88" d="100"/>
          <a:sy n="88" d="100"/>
        </p:scale>
        <p:origin x="162" y="60"/>
      </p:cViewPr>
      <p:guideLst>
        <p:guide pos="2842"/>
        <p:guide orient="horz" pos="177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737411-4D49-495D-8941-8FB3E9E34B63}" type="datetimeFigureOut">
              <a:rPr kumimoji="1" lang="ja-JP" altLang="en-US" smtClean="0"/>
              <a:t>2025/2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87198B-CCE1-417B-BC0A-FCE3D39F00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19433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0D3B3D-F9AA-43DD-9D0A-341C4E5277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DFFF26B-D937-456E-9EB7-03B5C62974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DBD1184-44F8-44D9-965E-E20C0C7660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1EC1E-457A-4F96-A160-328FE1AAAF77}" type="datetimeFigureOut">
              <a:rPr kumimoji="1" lang="ja-JP" altLang="en-US" smtClean="0"/>
              <a:t>2025/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4AB14F9-2B54-4A3D-9023-0A389675F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9B951F3-CCFF-4317-BEA6-265AD788A7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6E10-BEF3-45E1-8DB7-5B93DE779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5747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BC9872-36B8-4609-B5FE-14DE1D6954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0ACC86F-5F14-49D3-985C-112663A213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DF02E72-509C-4BE1-811B-83D4CD12F8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1EC1E-457A-4F96-A160-328FE1AAAF77}" type="datetimeFigureOut">
              <a:rPr kumimoji="1" lang="ja-JP" altLang="en-US" smtClean="0"/>
              <a:t>2025/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849B828-C41A-41BA-8075-731A7C0D6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9BA40F-C257-416F-8B72-01DB6AD12B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6E10-BEF3-45E1-8DB7-5B93DE779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7608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ECBEEEE-59E1-4CB3-9FD2-AD10AB183D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F96FA84-FEE4-42D3-BAF0-F386A6DE7E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BC4EB9-9A17-4263-8CE5-98A1284264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1EC1E-457A-4F96-A160-328FE1AAAF77}" type="datetimeFigureOut">
              <a:rPr kumimoji="1" lang="ja-JP" altLang="en-US" smtClean="0"/>
              <a:t>2025/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8D16327-A26E-43C5-87B2-050D7A7818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ACE7204-CC25-4769-A8BE-21E758CAC8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6E10-BEF3-45E1-8DB7-5B93DE779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685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04616B-522C-4248-B99A-234020771C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E0113D0-C460-4EE3-99EF-F256A8C4337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CF9C19F-75D3-47A1-A932-A465D1079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1EC1E-457A-4F96-A160-328FE1AAAF77}" type="datetimeFigureOut">
              <a:rPr kumimoji="1" lang="ja-JP" altLang="en-US" smtClean="0"/>
              <a:t>2025/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AAEC461-9F61-436B-B559-6A03427CC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FF2674-9824-4FF9-B7B9-F533BFA24B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6E10-BEF3-45E1-8DB7-5B93DE779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4558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1E2543-43B9-4E5F-86A2-D865691D8C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EDB096B-9347-44FE-9369-789EA79B0C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15C1954-2687-40A7-9A81-694D2AC9E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1EC1E-457A-4F96-A160-328FE1AAAF77}" type="datetimeFigureOut">
              <a:rPr kumimoji="1" lang="ja-JP" altLang="en-US" smtClean="0"/>
              <a:t>2025/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0E36A7-8655-4197-93C0-559FDD7D5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1CFDA76-8724-4EE1-9F9C-543BC7636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6E10-BEF3-45E1-8DB7-5B93DE779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9323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7E9BA9-001B-4BC8-B8A7-E40A50CE1F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409173D-2F16-46AA-9370-30854159C0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C9E90F1-D23D-43A6-AB6E-614A0867B7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7096EA5-91AE-4F7C-B5D5-91A72734A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1EC1E-457A-4F96-A160-328FE1AAAF77}" type="datetimeFigureOut">
              <a:rPr kumimoji="1" lang="ja-JP" altLang="en-US" smtClean="0"/>
              <a:t>2025/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C3E4CAF-4207-4A94-B7F7-E5171CB4D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171681F-2B8A-4F66-A3A0-82F5B2B7B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6E10-BEF3-45E1-8DB7-5B93DE779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8939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23DAA37-88B1-4BCA-9545-A8390F5597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ED49B90-D525-4E56-8B03-61858806B1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DEC60A2-202A-4827-A511-9E0B3EDD4A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60B5863-6FB7-4130-836D-6C26F63C3A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5782F4C-7BCF-4538-ADE2-40D3416EF8E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93D1364-AEF5-4EC1-9A9A-64B3284FD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1EC1E-457A-4F96-A160-328FE1AAAF77}" type="datetimeFigureOut">
              <a:rPr kumimoji="1" lang="ja-JP" altLang="en-US" smtClean="0"/>
              <a:t>2025/2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1EF0F6E-103B-4240-BEF6-69492B32B8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777080B-6AFF-47DD-8904-68B612EE7B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6E10-BEF3-45E1-8DB7-5B93DE779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58270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074C363-7710-4AB9-8D1E-21FAE40235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A433D3D-A113-493F-8432-74AEF9D548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1EC1E-457A-4F96-A160-328FE1AAAF77}" type="datetimeFigureOut">
              <a:rPr kumimoji="1" lang="ja-JP" altLang="en-US" smtClean="0"/>
              <a:t>2025/2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22CB482-2DD6-4F9D-BE52-849F52610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7631B1D-39AC-44C2-8B25-636D08C595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6E10-BEF3-45E1-8DB7-5B93DE779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6923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BB204D0-2EF1-4BD7-B73D-A25DD39586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1EC1E-457A-4F96-A160-328FE1AAAF77}" type="datetimeFigureOut">
              <a:rPr kumimoji="1" lang="ja-JP" altLang="en-US" smtClean="0"/>
              <a:t>2025/2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E7502CE-BC18-41D1-861B-5CCE48BF3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1669BA9-414D-4802-8C25-8955570AC2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6E10-BEF3-45E1-8DB7-5B93DE779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39498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A3C250-3510-4756-9BE1-7D1CFAF06B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2F85101-63B6-4E0C-9F05-5CED3D011F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8F023CB-8AF1-402F-96D4-2373BB8E0E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BE894F5-017D-4C5B-BF09-30DD0735E3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1EC1E-457A-4F96-A160-328FE1AAAF77}" type="datetimeFigureOut">
              <a:rPr kumimoji="1" lang="ja-JP" altLang="en-US" smtClean="0"/>
              <a:t>2025/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83B86CD-4BB8-4A30-BC62-D49222BAA9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C0848C5-380D-49D5-B3F6-813C6462D7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6E10-BEF3-45E1-8DB7-5B93DE779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7421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2EEA05-6DFE-444F-9B56-1713A191DC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36FDA2F-9505-45CA-993A-5C938ED6667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34C7ACC-8315-44D2-BFC2-AB1F58ABC6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6F9586F-88C5-469A-8B22-8BD313E56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1EC1E-457A-4F96-A160-328FE1AAAF77}" type="datetimeFigureOut">
              <a:rPr kumimoji="1" lang="ja-JP" altLang="en-US" smtClean="0"/>
              <a:t>2025/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CD82942-369F-4141-9E81-48B7709CC5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1EB36CC-B905-4DB2-89D0-D583F2DC53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6E10-BEF3-45E1-8DB7-5B93DE779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703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56C09AC-7ABD-45EF-ADED-4D2A9C630D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540DF5D-BC9F-4E12-A837-D7515A457B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587C62-A805-4EE3-9A5E-D0D096F68C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F1EC1E-457A-4F96-A160-328FE1AAAF77}" type="datetimeFigureOut">
              <a:rPr kumimoji="1" lang="ja-JP" altLang="en-US" smtClean="0"/>
              <a:t>2025/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F6643F1-5BDD-4433-A5F6-E421ED1E47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6850EE1-E027-4F0B-876A-0174ED70F5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216E10-BEF3-45E1-8DB7-5B93DE779D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5229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906E5DF-00D1-0B11-E1D6-09822F4FAB5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AF4AB45-D75F-8C1D-E46F-46B8F933AD0C}"/>
              </a:ext>
            </a:extLst>
          </p:cNvPr>
          <p:cNvSpPr txBox="1"/>
          <p:nvPr/>
        </p:nvSpPr>
        <p:spPr>
          <a:xfrm>
            <a:off x="544940" y="3431435"/>
            <a:ext cx="10233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The influence of WAY 100135 on anxiolytic behavior testing.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625B772-4C7A-F87E-B148-A83624286BF1}"/>
              </a:ext>
            </a:extLst>
          </p:cNvPr>
          <p:cNvSpPr txBox="1"/>
          <p:nvPr/>
        </p:nvSpPr>
        <p:spPr>
          <a:xfrm>
            <a:off x="526473" y="3801152"/>
            <a:ext cx="11490037" cy="11387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total distance moved (A), open arm frequency (B), closed arm frequency(C) during a 6-min elevated plus maze test. The mice were intraperitoneally administered with vehicle (saline containing 0.05% Tween 20) or WAY100135 (10 mg/kg) (n = 4-6). </a:t>
            </a:r>
            <a:r>
              <a:rPr lang="en-US" altLang="ja-JP" sz="1800" kern="0" dirty="0">
                <a:solidFill>
                  <a:srgbClr val="1C1D1E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s for t-tests in (A) and (B) and (C). Data represent the means ± SEM.</a:t>
            </a:r>
            <a:endParaRPr lang="ja-JP" altLang="ja-JP" sz="1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/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813182AE-8ED7-113D-0F51-453B3ACD17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5632" y="520874"/>
            <a:ext cx="9449619" cy="26702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53073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E50726D-E320-526A-3126-DF24CC7E783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4677AF5-A4FE-A9C0-C044-29C992A27276}"/>
              </a:ext>
            </a:extLst>
          </p:cNvPr>
          <p:cNvSpPr txBox="1"/>
          <p:nvPr/>
        </p:nvSpPr>
        <p:spPr>
          <a:xfrm>
            <a:off x="544946" y="3431438"/>
            <a:ext cx="10233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The influence of SCH 23390 on anxiolytic behavior testing.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1FE3D88-EAE2-ECB1-1FC4-F57F39B06E0C}"/>
              </a:ext>
            </a:extLst>
          </p:cNvPr>
          <p:cNvSpPr txBox="1"/>
          <p:nvPr/>
        </p:nvSpPr>
        <p:spPr>
          <a:xfrm>
            <a:off x="526473" y="3801152"/>
            <a:ext cx="11490037" cy="11387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total distance moved (A), open arm frequency (B), closed arm frequency(C) during a 6-min elevated plus maze test. The mice were intraperitoneally administered with vehicle (saline containing 0.05% Tween 20) or </a:t>
            </a:r>
            <a:r>
              <a:rPr lang="en-US" altLang="ja-JP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CH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23390 (1 </a:t>
            </a:r>
            <a:r>
              <a:rPr lang="en-US" altLang="ja-JP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μ</a:t>
            </a:r>
            <a:r>
              <a:rPr lang="en-US" altLang="ja-JP" sz="18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/mouse) (n = </a:t>
            </a:r>
            <a:r>
              <a:rPr lang="en-US" altLang="ja-JP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5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. </a:t>
            </a:r>
            <a:r>
              <a:rPr lang="en-US" altLang="ja-JP" sz="1800" kern="0" dirty="0">
                <a:solidFill>
                  <a:srgbClr val="1C1D1E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s for t-tests in (A) and (B) and (C). Data represent the means ± SEM.</a:t>
            </a:r>
            <a:endParaRPr lang="ja-JP" altLang="ja-JP" sz="1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/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AF0CF411-DDA4-79D3-C938-BC47CF6754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5231" y="523924"/>
            <a:ext cx="9345978" cy="26641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5230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44</TotalTime>
  <Words>180</Words>
  <Application>Microsoft Office PowerPoint</Application>
  <PresentationFormat>ワイド画面</PresentationFormat>
  <Paragraphs>4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金子lab</dc:creator>
  <cp:lastModifiedBy>KENTARO KANEKO</cp:lastModifiedBy>
  <cp:revision>48</cp:revision>
  <dcterms:created xsi:type="dcterms:W3CDTF">2024-02-21T07:33:03Z</dcterms:created>
  <dcterms:modified xsi:type="dcterms:W3CDTF">2025-02-22T01:26:39Z</dcterms:modified>
</cp:coreProperties>
</file>